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tr-T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AA006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660"/>
  </p:normalViewPr>
  <p:slideViewPr>
    <p:cSldViewPr snapToGrid="0">
      <p:cViewPr varScale="1">
        <p:scale>
          <a:sx n="75" d="100"/>
          <a:sy n="75" d="100"/>
        </p:scale>
        <p:origin x="902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Başlık Slayd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FB2D038F-8829-6959-3CC6-E3969322DE6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Alt Başlık 2">
            <a:extLst>
              <a:ext uri="{FF2B5EF4-FFF2-40B4-BE49-F238E27FC236}">
                <a16:creationId xmlns:a16="http://schemas.microsoft.com/office/drawing/2014/main" id="{DC2755F0-FE57-8905-F975-B7C8B9B168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tr-TR"/>
              <a:t>Asıl alt başlık stilini düzenlemek için tıklayın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E733160C-D1C6-08FB-1546-71CF86A8F0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1A894C8F-F6B3-AC6A-AC1F-0D48A864B5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9D2FAC69-B93F-35B8-55CF-44F86D4367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84798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Başlık ve Dikey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2F45CCA7-43EB-23D1-DED2-D3A752B694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F041EE43-EF63-D4A9-0A41-E925DB7F042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AEF56725-74E7-3F45-021F-79B1BE6832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47340E33-C4F4-DFF5-DB54-81C889D902D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469D663D-7340-2B2B-B717-20F87223AF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2634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Dikey Başlık ve Meti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ikey Başlık 1">
            <a:extLst>
              <a:ext uri="{FF2B5EF4-FFF2-40B4-BE49-F238E27FC236}">
                <a16:creationId xmlns:a16="http://schemas.microsoft.com/office/drawing/2014/main" id="{8CA71AC9-AB6D-DAC5-7614-497ADFEF7300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Dikey Metin Yer Tutucusu 2">
            <a:extLst>
              <a:ext uri="{FF2B5EF4-FFF2-40B4-BE49-F238E27FC236}">
                <a16:creationId xmlns:a16="http://schemas.microsoft.com/office/drawing/2014/main" id="{A3C59FBF-67C4-8197-A637-578CFF3D905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F6D0DD0B-D92E-300A-DCAB-8A4D8570C14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E9670A27-2321-AB2F-FAD5-7E37E894E1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D65B7FAD-41D4-1B70-BC47-34024B372F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255087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/>
          </a:p>
        </p:txBody>
      </p:sp>
    </p:spTree>
    <p:extLst>
      <p:ext uri="{BB962C8B-B14F-4D97-AF65-F5344CB8AC3E}">
        <p14:creationId xmlns:p14="http://schemas.microsoft.com/office/powerpoint/2010/main" val="221550894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aşlık ve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02C4B4A3-6B12-5A5B-F442-C2E16BE4D6A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9C294A0B-08E9-2299-403B-88B24E3338F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12BFC4F2-2B60-D34B-1C66-38DE64FC7A1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90D639A4-EAD5-AD52-FD99-76AA84C863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EDF44E63-39AC-1BD8-B61B-4A81137F945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34617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Bölüm Üst Bilgis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6EC9559B-5637-F703-8FC4-19D3E2D238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A68ABC39-3222-04A9-000E-46DB8CDE145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41022B31-26A8-ECC5-C476-9BF05FDFF16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E6DF3D8A-33EC-6DDA-545C-A0B249B09E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74DDC6FC-0E64-A8B0-CFBB-7BB46043A4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48950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İki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BDC9F40F-DE78-CCFC-2F5D-A46AD48F36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739D2DC7-CF72-1996-9908-57F779E3365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D12F3740-9C6D-1DC5-CB8E-A6BC6CB39F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E35E92D6-8F0E-1832-819E-C2675973A9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D76BA1D8-4E1D-45E8-D68B-BD0498BA73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A98F9277-9E2F-637A-B65A-9692110B1E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4800087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Karşılaştırm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2A3008B2-3396-8E5E-09BE-1026CA91642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3EFC77AD-AFB0-2C1A-5398-FDA2D5DCB49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4" name="İçerik Yer Tutucusu 3">
            <a:extLst>
              <a:ext uri="{FF2B5EF4-FFF2-40B4-BE49-F238E27FC236}">
                <a16:creationId xmlns:a16="http://schemas.microsoft.com/office/drawing/2014/main" id="{C79D7C0F-E718-3EAB-972E-8D6BE98E899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5" name="Metin Yer Tutucusu 4">
            <a:extLst>
              <a:ext uri="{FF2B5EF4-FFF2-40B4-BE49-F238E27FC236}">
                <a16:creationId xmlns:a16="http://schemas.microsoft.com/office/drawing/2014/main" id="{3FD2D7E8-94EC-A080-3084-569BC0EBC4D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6" name="İçerik Yer Tutucusu 5">
            <a:extLst>
              <a:ext uri="{FF2B5EF4-FFF2-40B4-BE49-F238E27FC236}">
                <a16:creationId xmlns:a16="http://schemas.microsoft.com/office/drawing/2014/main" id="{4E0D8EE3-E7F0-FC49-B509-862EEDA62A7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7" name="Veri Yer Tutucusu 6">
            <a:extLst>
              <a:ext uri="{FF2B5EF4-FFF2-40B4-BE49-F238E27FC236}">
                <a16:creationId xmlns:a16="http://schemas.microsoft.com/office/drawing/2014/main" id="{4E1103AC-3F79-79F8-85CB-F770F9A8C0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8" name="Alt Bilgi Yer Tutucusu 7">
            <a:extLst>
              <a:ext uri="{FF2B5EF4-FFF2-40B4-BE49-F238E27FC236}">
                <a16:creationId xmlns:a16="http://schemas.microsoft.com/office/drawing/2014/main" id="{064BAB22-7F81-5067-6332-116EF614A6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ayt Numarası Yer Tutucusu 8">
            <a:extLst>
              <a:ext uri="{FF2B5EF4-FFF2-40B4-BE49-F238E27FC236}">
                <a16:creationId xmlns:a16="http://schemas.microsoft.com/office/drawing/2014/main" id="{8F6A94C7-2756-6211-7CEB-613D4CD398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17752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Yalnızca Başlı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156402DE-7C71-5765-A956-5B73957920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Veri Yer Tutucusu 2">
            <a:extLst>
              <a:ext uri="{FF2B5EF4-FFF2-40B4-BE49-F238E27FC236}">
                <a16:creationId xmlns:a16="http://schemas.microsoft.com/office/drawing/2014/main" id="{B2D7BCC8-6107-042B-8FB7-3A9E6C9397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4" name="Alt Bilgi Yer Tutucusu 3">
            <a:extLst>
              <a:ext uri="{FF2B5EF4-FFF2-40B4-BE49-F238E27FC236}">
                <a16:creationId xmlns:a16="http://schemas.microsoft.com/office/drawing/2014/main" id="{A40076A9-A696-3A79-8101-042685BB670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ayt Numarası Yer Tutucusu 4">
            <a:extLst>
              <a:ext uri="{FF2B5EF4-FFF2-40B4-BE49-F238E27FC236}">
                <a16:creationId xmlns:a16="http://schemas.microsoft.com/office/drawing/2014/main" id="{4CBF5F3E-AB3B-5626-CF1E-53C6604091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67793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oş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i Yer Tutucusu 1">
            <a:extLst>
              <a:ext uri="{FF2B5EF4-FFF2-40B4-BE49-F238E27FC236}">
                <a16:creationId xmlns:a16="http://schemas.microsoft.com/office/drawing/2014/main" id="{CE358427-B600-F543-E5A0-ECFB8414C3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3" name="Alt Bilgi Yer Tutucusu 2">
            <a:extLst>
              <a:ext uri="{FF2B5EF4-FFF2-40B4-BE49-F238E27FC236}">
                <a16:creationId xmlns:a16="http://schemas.microsoft.com/office/drawing/2014/main" id="{B5E788C7-7C41-00AA-3535-FCD2FE0644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ayt Numarası Yer Tutucusu 3">
            <a:extLst>
              <a:ext uri="{FF2B5EF4-FFF2-40B4-BE49-F238E27FC236}">
                <a16:creationId xmlns:a16="http://schemas.microsoft.com/office/drawing/2014/main" id="{D261CB1F-EDA0-516C-BDCD-C713586F0F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9602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Başlıklı İçeri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1D7CD8DB-12FD-C969-4BDF-7D014112E5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İçerik Yer Tutucusu 2">
            <a:extLst>
              <a:ext uri="{FF2B5EF4-FFF2-40B4-BE49-F238E27FC236}">
                <a16:creationId xmlns:a16="http://schemas.microsoft.com/office/drawing/2014/main" id="{6F58C1A4-990F-7A8F-669C-C90A1FA2F58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FE3410E4-4E5A-3105-AF44-ACF9B480505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DBAA3A40-7F0E-D366-E47B-57305D9CE31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E60429B2-57AC-4882-A5FD-A71D8DA901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068632AF-201D-5FFC-0719-6130E1C655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170521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aşlıklı Resi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1">
            <a:extLst>
              <a:ext uri="{FF2B5EF4-FFF2-40B4-BE49-F238E27FC236}">
                <a16:creationId xmlns:a16="http://schemas.microsoft.com/office/drawing/2014/main" id="{A86F9B13-B451-60F7-DA2E-84882923F8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Resim Yer Tutucusu 2">
            <a:extLst>
              <a:ext uri="{FF2B5EF4-FFF2-40B4-BE49-F238E27FC236}">
                <a16:creationId xmlns:a16="http://schemas.microsoft.com/office/drawing/2014/main" id="{04EF24F6-8CE1-D24C-2DAB-3D7FC9A4898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etin Yer Tutucusu 3">
            <a:extLst>
              <a:ext uri="{FF2B5EF4-FFF2-40B4-BE49-F238E27FC236}">
                <a16:creationId xmlns:a16="http://schemas.microsoft.com/office/drawing/2014/main" id="{2B3C7CA9-9387-709A-208A-B72F02FF922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tr-TR"/>
              <a:t>Asıl metin stillerini düzenlemek için tıklayın</a:t>
            </a:r>
          </a:p>
        </p:txBody>
      </p:sp>
      <p:sp>
        <p:nvSpPr>
          <p:cNvPr id="5" name="Veri Yer Tutucusu 4">
            <a:extLst>
              <a:ext uri="{FF2B5EF4-FFF2-40B4-BE49-F238E27FC236}">
                <a16:creationId xmlns:a16="http://schemas.microsoft.com/office/drawing/2014/main" id="{49416FD3-2EB0-13AA-F8FA-CF8DD0D7A1D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6" name="Alt Bilgi Yer Tutucusu 5">
            <a:extLst>
              <a:ext uri="{FF2B5EF4-FFF2-40B4-BE49-F238E27FC236}">
                <a16:creationId xmlns:a16="http://schemas.microsoft.com/office/drawing/2014/main" id="{288031B7-342D-726A-3E23-27C51282D7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ayt Numarası Yer Tutucusu 6">
            <a:extLst>
              <a:ext uri="{FF2B5EF4-FFF2-40B4-BE49-F238E27FC236}">
                <a16:creationId xmlns:a16="http://schemas.microsoft.com/office/drawing/2014/main" id="{6D159899-9FAA-BD18-7C59-605C01BE54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918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Başlık Yer Tutucusu 1">
            <a:extLst>
              <a:ext uri="{FF2B5EF4-FFF2-40B4-BE49-F238E27FC236}">
                <a16:creationId xmlns:a16="http://schemas.microsoft.com/office/drawing/2014/main" id="{B0B1FF27-5B7A-1104-B9A8-7E2A85B96D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tr-TR"/>
              <a:t>Asıl başlık stilini düzenlemek için tıklayın</a:t>
            </a:r>
            <a:endParaRPr lang="en-US"/>
          </a:p>
        </p:txBody>
      </p:sp>
      <p:sp>
        <p:nvSpPr>
          <p:cNvPr id="3" name="Metin Yer Tutucusu 2">
            <a:extLst>
              <a:ext uri="{FF2B5EF4-FFF2-40B4-BE49-F238E27FC236}">
                <a16:creationId xmlns:a16="http://schemas.microsoft.com/office/drawing/2014/main" id="{CC8B9326-11F9-1378-E3DF-71CA2E05543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tr-TR"/>
              <a:t>Asıl metin stillerini düzenlemek için tıklayın</a:t>
            </a:r>
          </a:p>
          <a:p>
            <a:pPr lvl="1"/>
            <a:r>
              <a:rPr lang="tr-TR"/>
              <a:t>İkinci düzey</a:t>
            </a:r>
          </a:p>
          <a:p>
            <a:pPr lvl="2"/>
            <a:r>
              <a:rPr lang="tr-TR"/>
              <a:t>Üçüncü düzey</a:t>
            </a:r>
          </a:p>
          <a:p>
            <a:pPr lvl="3"/>
            <a:r>
              <a:rPr lang="tr-TR"/>
              <a:t>Dördüncü düzey</a:t>
            </a:r>
          </a:p>
          <a:p>
            <a:pPr lvl="4"/>
            <a:r>
              <a:rPr lang="tr-TR"/>
              <a:t>Beşinci düzey</a:t>
            </a:r>
            <a:endParaRPr lang="en-US"/>
          </a:p>
        </p:txBody>
      </p:sp>
      <p:sp>
        <p:nvSpPr>
          <p:cNvPr id="4" name="Veri Yer Tutucusu 3">
            <a:extLst>
              <a:ext uri="{FF2B5EF4-FFF2-40B4-BE49-F238E27FC236}">
                <a16:creationId xmlns:a16="http://schemas.microsoft.com/office/drawing/2014/main" id="{91274DA3-8D50-E505-6B95-6959D5658D8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C79DA89-52E7-4331-89C6-40C75964CC99}" type="datetimeFigureOut">
              <a:rPr lang="en-US" smtClean="0"/>
              <a:t>4/20/2025</a:t>
            </a:fld>
            <a:endParaRPr lang="en-US"/>
          </a:p>
        </p:txBody>
      </p:sp>
      <p:sp>
        <p:nvSpPr>
          <p:cNvPr id="5" name="Alt Bilgi Yer Tutucusu 4">
            <a:extLst>
              <a:ext uri="{FF2B5EF4-FFF2-40B4-BE49-F238E27FC236}">
                <a16:creationId xmlns:a16="http://schemas.microsoft.com/office/drawing/2014/main" id="{5A497A64-913D-F26B-57DA-68EAD6392E3B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ayt Numarası Yer Tutucusu 5">
            <a:extLst>
              <a:ext uri="{FF2B5EF4-FFF2-40B4-BE49-F238E27FC236}">
                <a16:creationId xmlns:a16="http://schemas.microsoft.com/office/drawing/2014/main" id="{D1C2F195-63C4-674F-63EB-5E58C744BD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95964AF-B2F4-4ACD-8492-361B8F945BD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3210639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tr-T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8192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algn="l"/>
            <a:r>
              <a:rPr lang="en-US" sz="2700" b="1" dirty="0">
                <a:solidFill>
                  <a:schemeClr val="bg1"/>
                </a:solidFill>
                <a:latin typeface="Calibri Light" panose="020F0302020204030204" pitchFamily="34" charset="0"/>
                <a:ea typeface="Calibri Light" panose="020F0302020204030204" pitchFamily="34" charset="0"/>
                <a:cs typeface="Calibri Light" panose="020F0302020204030204" pitchFamily="34" charset="0"/>
              </a:rPr>
              <a:t>Unmasking fluid overload in children on peritoneal dialysis: A multimodal diagnostic approach</a:t>
            </a:r>
            <a:endParaRPr lang="en-GB" sz="2700" b="1" dirty="0">
              <a:solidFill>
                <a:schemeClr val="bg1"/>
              </a:solidFill>
              <a:latin typeface="Calibri Light" panose="020F0302020204030204" pitchFamily="34" charset="0"/>
              <a:ea typeface="Calibri Light" panose="020F0302020204030204" pitchFamily="34" charset="0"/>
              <a:cs typeface="Calibri Light" panose="020F030202020403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016973"/>
            <a:ext cx="11838369" cy="63094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IM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</a:t>
            </a:r>
            <a:r>
              <a:rPr lang="tr-TR" sz="1700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</a:t>
            </a:r>
            <a:r>
              <a:rPr lang="en-US" sz="1700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 assess fluid status in pediatric peritoneal dialysis patients by combining ultrasonography and bioimpedance spectroscopy, with a particular focus on examining changes in volume status following a 2-hour dwell time ultrafiltration exchange</a:t>
            </a:r>
            <a:endParaRPr lang="en-GB" sz="1700" dirty="0">
              <a:solidFill>
                <a:schemeClr val="bg1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6" name="TextBox 25"/>
          <p:cNvSpPr txBox="1"/>
          <p:nvPr/>
        </p:nvSpPr>
        <p:spPr>
          <a:xfrm>
            <a:off x="173448" y="1758951"/>
            <a:ext cx="115059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rgbClr val="0065A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SIGN &amp; OUTCOMES</a:t>
            </a:r>
            <a:r>
              <a:rPr lang="tr-TR" b="1" dirty="0">
                <a:solidFill>
                  <a:srgbClr val="0065A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</a:t>
            </a:r>
          </a:p>
          <a:p>
            <a:endParaRPr lang="en-GB" dirty="0">
              <a:solidFill>
                <a:srgbClr val="0065AA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tr-TR" sz="2000" b="1" dirty="0" err="1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tmis</a:t>
            </a:r>
            <a:r>
              <a:rPr lang="tr-TR" sz="2000" b="1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sz="2000" b="1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et al. 202</a:t>
            </a:r>
            <a:r>
              <a:rPr lang="tr-TR" sz="2000" b="1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</a:t>
            </a:r>
            <a:endParaRPr lang="en-GB" sz="1400" b="1" dirty="0">
              <a:solidFill>
                <a:schemeClr val="bg1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275744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CONCLUSION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: Our results highlight marked changes in fluid status parameters from pre- to post-dialysis, underscoring the clinical value of combining lung ultrasonography and BIS for monitoring fluid overload in </a:t>
            </a:r>
            <a:r>
              <a:rPr lang="en-US" noProof="0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diatric p</a:t>
            </a:r>
            <a:r>
              <a:rPr lang="en-GB" dirty="0" err="1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tients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tr-TR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on </a:t>
            </a:r>
            <a:r>
              <a:rPr lang="en-GB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eritoneal dialysis</a:t>
            </a:r>
            <a:r>
              <a:rPr lang="tr-TR" dirty="0">
                <a:solidFill>
                  <a:schemeClr val="bg1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.</a:t>
            </a:r>
            <a:endParaRPr lang="en-GB" dirty="0">
              <a:solidFill>
                <a:schemeClr val="bg1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endParaRPr lang="en-GB" dirty="0">
              <a:solidFill>
                <a:schemeClr val="bg1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4" name="Rectangle 48">
            <a:extLst>
              <a:ext uri="{FF2B5EF4-FFF2-40B4-BE49-F238E27FC236}">
                <a16:creationId xmlns:a16="http://schemas.microsoft.com/office/drawing/2014/main" id="{8F4AAAAB-7224-2DB9-5EE3-6DCAD91D59AE}"/>
              </a:ext>
            </a:extLst>
          </p:cNvPr>
          <p:cNvSpPr/>
          <p:nvPr/>
        </p:nvSpPr>
        <p:spPr>
          <a:xfrm>
            <a:off x="173448" y="2153676"/>
            <a:ext cx="1699818" cy="774587"/>
          </a:xfrm>
          <a:prstGeom prst="rect">
            <a:avLst/>
          </a:prstGeom>
          <a:noFill/>
          <a:ln w="41275">
            <a:solidFill>
              <a:srgbClr val="296DC0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600" noProof="0" dirty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13 pediatric</a:t>
            </a:r>
            <a:r>
              <a:rPr lang="tr-TR" sz="1600" dirty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noProof="0" dirty="0">
                <a:solidFill>
                  <a:srgbClr val="296DC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patients on peritoneal dialysis</a:t>
            </a:r>
          </a:p>
        </p:txBody>
      </p:sp>
      <p:sp>
        <p:nvSpPr>
          <p:cNvPr id="5" name="Freeform: Shape 46">
            <a:extLst>
              <a:ext uri="{FF2B5EF4-FFF2-40B4-BE49-F238E27FC236}">
                <a16:creationId xmlns:a16="http://schemas.microsoft.com/office/drawing/2014/main" id="{0D24126F-EAE5-D20D-F42B-1766CF91F66A}"/>
              </a:ext>
            </a:extLst>
          </p:cNvPr>
          <p:cNvSpPr/>
          <p:nvPr/>
        </p:nvSpPr>
        <p:spPr>
          <a:xfrm>
            <a:off x="819647" y="3041672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296DC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6" name="TextBox 32">
            <a:extLst>
              <a:ext uri="{FF2B5EF4-FFF2-40B4-BE49-F238E27FC236}">
                <a16:creationId xmlns:a16="http://schemas.microsoft.com/office/drawing/2014/main" id="{C7E7A74B-622B-3DB5-4C05-28DAE58083DD}"/>
              </a:ext>
            </a:extLst>
          </p:cNvPr>
          <p:cNvSpPr txBox="1"/>
          <p:nvPr/>
        </p:nvSpPr>
        <p:spPr>
          <a:xfrm>
            <a:off x="2288427" y="4076909"/>
            <a:ext cx="30839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003969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6 BIS evaluations</a:t>
            </a:r>
            <a:endParaRPr lang="en-GB" sz="2000" dirty="0">
              <a:solidFill>
                <a:srgbClr val="003969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cxnSp>
        <p:nvCxnSpPr>
          <p:cNvPr id="7" name="Straight Arrow Connector 17">
            <a:extLst>
              <a:ext uri="{FF2B5EF4-FFF2-40B4-BE49-F238E27FC236}">
                <a16:creationId xmlns:a16="http://schemas.microsoft.com/office/drawing/2014/main" id="{19A11E2D-D22E-4EFC-13A7-2A1AB5260D43}"/>
              </a:ext>
            </a:extLst>
          </p:cNvPr>
          <p:cNvCxnSpPr/>
          <p:nvPr/>
        </p:nvCxnSpPr>
        <p:spPr>
          <a:xfrm>
            <a:off x="1660055" y="3582565"/>
            <a:ext cx="715833" cy="0"/>
          </a:xfrm>
          <a:prstGeom prst="straightConnector1">
            <a:avLst/>
          </a:prstGeom>
          <a:ln w="31750">
            <a:solidFill>
              <a:srgbClr val="AA0065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Straight Arrow Connector 44">
            <a:extLst>
              <a:ext uri="{FF2B5EF4-FFF2-40B4-BE49-F238E27FC236}">
                <a16:creationId xmlns:a16="http://schemas.microsoft.com/office/drawing/2014/main" id="{104AB1D7-AA83-E3B3-E14A-0A5F1468427F}"/>
              </a:ext>
            </a:extLst>
          </p:cNvPr>
          <p:cNvCxnSpPr/>
          <p:nvPr/>
        </p:nvCxnSpPr>
        <p:spPr>
          <a:xfrm flipV="1">
            <a:off x="1660054" y="2898767"/>
            <a:ext cx="628373" cy="468037"/>
          </a:xfrm>
          <a:prstGeom prst="straightConnector1">
            <a:avLst/>
          </a:prstGeom>
          <a:ln w="31750">
            <a:solidFill>
              <a:srgbClr val="65AA0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Straight Arrow Connector 46">
            <a:extLst>
              <a:ext uri="{FF2B5EF4-FFF2-40B4-BE49-F238E27FC236}">
                <a16:creationId xmlns:a16="http://schemas.microsoft.com/office/drawing/2014/main" id="{3611037E-EC32-DFD4-590A-79BC20806E7C}"/>
              </a:ext>
            </a:extLst>
          </p:cNvPr>
          <p:cNvCxnSpPr/>
          <p:nvPr/>
        </p:nvCxnSpPr>
        <p:spPr>
          <a:xfrm>
            <a:off x="1674590" y="3822429"/>
            <a:ext cx="613837" cy="461154"/>
          </a:xfrm>
          <a:prstGeom prst="straightConnector1">
            <a:avLst/>
          </a:prstGeom>
          <a:ln w="31750">
            <a:solidFill>
              <a:srgbClr val="003969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" name="TextBox 32">
            <a:extLst>
              <a:ext uri="{FF2B5EF4-FFF2-40B4-BE49-F238E27FC236}">
                <a16:creationId xmlns:a16="http://schemas.microsoft.com/office/drawing/2014/main" id="{9F1B4D64-73E3-B895-14FA-0E977B40F955}"/>
              </a:ext>
            </a:extLst>
          </p:cNvPr>
          <p:cNvSpPr txBox="1"/>
          <p:nvPr/>
        </p:nvSpPr>
        <p:spPr>
          <a:xfrm>
            <a:off x="2300862" y="2686642"/>
            <a:ext cx="3083926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65AA00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6 lung ultrasound</a:t>
            </a:r>
            <a:endParaRPr lang="en-GB" sz="2000" dirty="0">
              <a:solidFill>
                <a:srgbClr val="65AA00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2" name="TextBox 32">
            <a:extLst>
              <a:ext uri="{FF2B5EF4-FFF2-40B4-BE49-F238E27FC236}">
                <a16:creationId xmlns:a16="http://schemas.microsoft.com/office/drawing/2014/main" id="{FB1D30E3-6C27-DB19-3688-5561DC06706D}"/>
              </a:ext>
            </a:extLst>
          </p:cNvPr>
          <p:cNvSpPr txBox="1"/>
          <p:nvPr/>
        </p:nvSpPr>
        <p:spPr>
          <a:xfrm>
            <a:off x="2300862" y="3251515"/>
            <a:ext cx="3083926" cy="7078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>
                <a:solidFill>
                  <a:srgbClr val="AA0065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56 inferior vena cava (IVC) collapsibility index</a:t>
            </a:r>
          </a:p>
        </p:txBody>
      </p:sp>
      <p:sp>
        <p:nvSpPr>
          <p:cNvPr id="14" name="Freeform: Shape 46">
            <a:extLst>
              <a:ext uri="{FF2B5EF4-FFF2-40B4-BE49-F238E27FC236}">
                <a16:creationId xmlns:a16="http://schemas.microsoft.com/office/drawing/2014/main" id="{42F390D6-8F15-19A0-3EF0-858F0486DE64}"/>
              </a:ext>
            </a:extLst>
          </p:cNvPr>
          <p:cNvSpPr/>
          <p:nvPr/>
        </p:nvSpPr>
        <p:spPr>
          <a:xfrm>
            <a:off x="469426" y="325661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00437A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 dirty="0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5" name="Freeform: Shape 46">
            <a:extLst>
              <a:ext uri="{FF2B5EF4-FFF2-40B4-BE49-F238E27FC236}">
                <a16:creationId xmlns:a16="http://schemas.microsoft.com/office/drawing/2014/main" id="{7FA90F81-2627-C725-70A6-CE85F4D7DCD2}"/>
              </a:ext>
            </a:extLst>
          </p:cNvPr>
          <p:cNvSpPr/>
          <p:nvPr/>
        </p:nvSpPr>
        <p:spPr>
          <a:xfrm>
            <a:off x="1076289" y="3256619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65AA00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16" name="Freeform: Shape 46">
            <a:extLst>
              <a:ext uri="{FF2B5EF4-FFF2-40B4-BE49-F238E27FC236}">
                <a16:creationId xmlns:a16="http://schemas.microsoft.com/office/drawing/2014/main" id="{D938273C-5C55-882B-7BE2-4891E7F071CF}"/>
              </a:ext>
            </a:extLst>
          </p:cNvPr>
          <p:cNvSpPr/>
          <p:nvPr/>
        </p:nvSpPr>
        <p:spPr>
          <a:xfrm>
            <a:off x="818063" y="3512664"/>
            <a:ext cx="513284" cy="1049898"/>
          </a:xfrm>
          <a:custGeom>
            <a:avLst/>
            <a:gdLst>
              <a:gd name="connsiteX0" fmla="*/ 427832 w 855663"/>
              <a:gd name="connsiteY0" fmla="*/ 350043 h 1750218"/>
              <a:gd name="connsiteX1" fmla="*/ 556181 w 855663"/>
              <a:gd name="connsiteY1" fmla="*/ 365601 h 1750218"/>
              <a:gd name="connsiteX2" fmla="*/ 719535 w 855663"/>
              <a:gd name="connsiteY2" fmla="*/ 451168 h 1750218"/>
              <a:gd name="connsiteX3" fmla="*/ 742872 w 855663"/>
              <a:gd name="connsiteY3" fmla="*/ 493950 h 1750218"/>
              <a:gd name="connsiteX4" fmla="*/ 851774 w 855663"/>
              <a:gd name="connsiteY4" fmla="*/ 956786 h 1750218"/>
              <a:gd name="connsiteX5" fmla="*/ 855663 w 855663"/>
              <a:gd name="connsiteY5" fmla="*/ 976232 h 1750218"/>
              <a:gd name="connsiteX6" fmla="*/ 777876 w 855663"/>
              <a:gd name="connsiteY6" fmla="*/ 1054020 h 1750218"/>
              <a:gd name="connsiteX7" fmla="*/ 703977 w 855663"/>
              <a:gd name="connsiteY7" fmla="*/ 995680 h 1750218"/>
              <a:gd name="connsiteX8" fmla="*/ 622301 w 855663"/>
              <a:gd name="connsiteY8" fmla="*/ 657304 h 1750218"/>
              <a:gd name="connsiteX9" fmla="*/ 622301 w 855663"/>
              <a:gd name="connsiteY9" fmla="*/ 1750218 h 1750218"/>
              <a:gd name="connsiteX10" fmla="*/ 466726 w 855663"/>
              <a:gd name="connsiteY10" fmla="*/ 1750218 h 1750218"/>
              <a:gd name="connsiteX11" fmla="*/ 466726 w 855663"/>
              <a:gd name="connsiteY11" fmla="*/ 1050131 h 1750218"/>
              <a:gd name="connsiteX12" fmla="*/ 388938 w 855663"/>
              <a:gd name="connsiteY12" fmla="*/ 1050131 h 1750218"/>
              <a:gd name="connsiteX13" fmla="*/ 388938 w 855663"/>
              <a:gd name="connsiteY13" fmla="*/ 1750218 h 1750218"/>
              <a:gd name="connsiteX14" fmla="*/ 233363 w 855663"/>
              <a:gd name="connsiteY14" fmla="*/ 1750218 h 1750218"/>
              <a:gd name="connsiteX15" fmla="*/ 233363 w 855663"/>
              <a:gd name="connsiteY15" fmla="*/ 661193 h 1750218"/>
              <a:gd name="connsiteX16" fmla="*/ 151686 w 855663"/>
              <a:gd name="connsiteY16" fmla="*/ 999569 h 1750218"/>
              <a:gd name="connsiteX17" fmla="*/ 77788 w 855663"/>
              <a:gd name="connsiteY17" fmla="*/ 1057910 h 1750218"/>
              <a:gd name="connsiteX18" fmla="*/ 0 w 855663"/>
              <a:gd name="connsiteY18" fmla="*/ 980123 h 1750218"/>
              <a:gd name="connsiteX19" fmla="*/ 3889 w 855663"/>
              <a:gd name="connsiteY19" fmla="*/ 960675 h 1750218"/>
              <a:gd name="connsiteX20" fmla="*/ 112792 w 855663"/>
              <a:gd name="connsiteY20" fmla="*/ 497840 h 1750218"/>
              <a:gd name="connsiteX21" fmla="*/ 136129 w 855663"/>
              <a:gd name="connsiteY21" fmla="*/ 455057 h 1750218"/>
              <a:gd name="connsiteX22" fmla="*/ 299482 w 855663"/>
              <a:gd name="connsiteY22" fmla="*/ 369490 h 1750218"/>
              <a:gd name="connsiteX23" fmla="*/ 427832 w 855663"/>
              <a:gd name="connsiteY23" fmla="*/ 350043 h 1750218"/>
              <a:gd name="connsiteX24" fmla="*/ 427831 w 855663"/>
              <a:gd name="connsiteY24" fmla="*/ 0 h 1750218"/>
              <a:gd name="connsiteX25" fmla="*/ 583406 w 855663"/>
              <a:gd name="connsiteY25" fmla="*/ 155575 h 1750218"/>
              <a:gd name="connsiteX26" fmla="*/ 427831 w 855663"/>
              <a:gd name="connsiteY26" fmla="*/ 311150 h 1750218"/>
              <a:gd name="connsiteX27" fmla="*/ 272256 w 855663"/>
              <a:gd name="connsiteY27" fmla="*/ 155575 h 1750218"/>
              <a:gd name="connsiteX28" fmla="*/ 427831 w 855663"/>
              <a:gd name="connsiteY28" fmla="*/ 0 h 175021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  <a:cxn ang="0">
                <a:pos x="connsiteX6" y="connsiteY6"/>
              </a:cxn>
              <a:cxn ang="0">
                <a:pos x="connsiteX7" y="connsiteY7"/>
              </a:cxn>
              <a:cxn ang="0">
                <a:pos x="connsiteX8" y="connsiteY8"/>
              </a:cxn>
              <a:cxn ang="0">
                <a:pos x="connsiteX9" y="connsiteY9"/>
              </a:cxn>
              <a:cxn ang="0">
                <a:pos x="connsiteX10" y="connsiteY10"/>
              </a:cxn>
              <a:cxn ang="0">
                <a:pos x="connsiteX11" y="connsiteY11"/>
              </a:cxn>
              <a:cxn ang="0">
                <a:pos x="connsiteX12" y="connsiteY12"/>
              </a:cxn>
              <a:cxn ang="0">
                <a:pos x="connsiteX13" y="connsiteY13"/>
              </a:cxn>
              <a:cxn ang="0">
                <a:pos x="connsiteX14" y="connsiteY14"/>
              </a:cxn>
              <a:cxn ang="0">
                <a:pos x="connsiteX15" y="connsiteY15"/>
              </a:cxn>
              <a:cxn ang="0">
                <a:pos x="connsiteX16" y="connsiteY16"/>
              </a:cxn>
              <a:cxn ang="0">
                <a:pos x="connsiteX17" y="connsiteY17"/>
              </a:cxn>
              <a:cxn ang="0">
                <a:pos x="connsiteX18" y="connsiteY18"/>
              </a:cxn>
              <a:cxn ang="0">
                <a:pos x="connsiteX19" y="connsiteY19"/>
              </a:cxn>
              <a:cxn ang="0">
                <a:pos x="connsiteX20" y="connsiteY20"/>
              </a:cxn>
              <a:cxn ang="0">
                <a:pos x="connsiteX21" y="connsiteY21"/>
              </a:cxn>
              <a:cxn ang="0">
                <a:pos x="connsiteX22" y="connsiteY22"/>
              </a:cxn>
              <a:cxn ang="0">
                <a:pos x="connsiteX23" y="connsiteY23"/>
              </a:cxn>
              <a:cxn ang="0">
                <a:pos x="connsiteX24" y="connsiteY24"/>
              </a:cxn>
              <a:cxn ang="0">
                <a:pos x="connsiteX25" y="connsiteY25"/>
              </a:cxn>
              <a:cxn ang="0">
                <a:pos x="connsiteX26" y="connsiteY26"/>
              </a:cxn>
              <a:cxn ang="0">
                <a:pos x="connsiteX27" y="connsiteY27"/>
              </a:cxn>
              <a:cxn ang="0">
                <a:pos x="connsiteX28" y="connsiteY28"/>
              </a:cxn>
            </a:cxnLst>
            <a:rect l="l" t="t" r="r" b="b"/>
            <a:pathLst>
              <a:path w="855663" h="1750218">
                <a:moveTo>
                  <a:pt x="427832" y="350043"/>
                </a:moveTo>
                <a:cubicBezTo>
                  <a:pt x="470615" y="350043"/>
                  <a:pt x="513398" y="357821"/>
                  <a:pt x="556181" y="365601"/>
                </a:cubicBezTo>
                <a:cubicBezTo>
                  <a:pt x="618412" y="385047"/>
                  <a:pt x="672862" y="412273"/>
                  <a:pt x="719535" y="451168"/>
                </a:cubicBezTo>
                <a:cubicBezTo>
                  <a:pt x="731203" y="462835"/>
                  <a:pt x="738983" y="478392"/>
                  <a:pt x="742872" y="493950"/>
                </a:cubicBezTo>
                <a:lnTo>
                  <a:pt x="851774" y="956786"/>
                </a:lnTo>
                <a:cubicBezTo>
                  <a:pt x="851774" y="960675"/>
                  <a:pt x="855663" y="968454"/>
                  <a:pt x="855663" y="976232"/>
                </a:cubicBezTo>
                <a:cubicBezTo>
                  <a:pt x="855663" y="1019016"/>
                  <a:pt x="820659" y="1054020"/>
                  <a:pt x="777876" y="1054020"/>
                </a:cubicBezTo>
                <a:cubicBezTo>
                  <a:pt x="742872" y="1054020"/>
                  <a:pt x="711757" y="1026795"/>
                  <a:pt x="703977" y="995680"/>
                </a:cubicBezTo>
                <a:lnTo>
                  <a:pt x="622301" y="657304"/>
                </a:lnTo>
                <a:lnTo>
                  <a:pt x="622301" y="1750218"/>
                </a:lnTo>
                <a:lnTo>
                  <a:pt x="466726" y="1750218"/>
                </a:lnTo>
                <a:lnTo>
                  <a:pt x="466726" y="1050131"/>
                </a:lnTo>
                <a:lnTo>
                  <a:pt x="388938" y="1050131"/>
                </a:lnTo>
                <a:lnTo>
                  <a:pt x="388938" y="1750218"/>
                </a:lnTo>
                <a:lnTo>
                  <a:pt x="233363" y="1750218"/>
                </a:lnTo>
                <a:lnTo>
                  <a:pt x="233363" y="661193"/>
                </a:lnTo>
                <a:lnTo>
                  <a:pt x="151686" y="999569"/>
                </a:lnTo>
                <a:cubicBezTo>
                  <a:pt x="143907" y="1030684"/>
                  <a:pt x="112792" y="1057910"/>
                  <a:pt x="77788" y="1057910"/>
                </a:cubicBezTo>
                <a:cubicBezTo>
                  <a:pt x="35004" y="1057910"/>
                  <a:pt x="0" y="1022905"/>
                  <a:pt x="0" y="980123"/>
                </a:cubicBezTo>
                <a:cubicBezTo>
                  <a:pt x="0" y="972343"/>
                  <a:pt x="3889" y="964564"/>
                  <a:pt x="3889" y="960675"/>
                </a:cubicBezTo>
                <a:lnTo>
                  <a:pt x="112792" y="497840"/>
                </a:lnTo>
                <a:cubicBezTo>
                  <a:pt x="116682" y="482281"/>
                  <a:pt x="124460" y="466725"/>
                  <a:pt x="136129" y="455057"/>
                </a:cubicBezTo>
                <a:cubicBezTo>
                  <a:pt x="182801" y="416162"/>
                  <a:pt x="237252" y="385047"/>
                  <a:pt x="299482" y="369490"/>
                </a:cubicBezTo>
                <a:cubicBezTo>
                  <a:pt x="342265" y="357821"/>
                  <a:pt x="385049" y="350043"/>
                  <a:pt x="427832" y="350043"/>
                </a:cubicBezTo>
                <a:close/>
                <a:moveTo>
                  <a:pt x="427831" y="0"/>
                </a:moveTo>
                <a:cubicBezTo>
                  <a:pt x="513753" y="0"/>
                  <a:pt x="583406" y="69653"/>
                  <a:pt x="583406" y="155575"/>
                </a:cubicBezTo>
                <a:cubicBezTo>
                  <a:pt x="583406" y="241496"/>
                  <a:pt x="513753" y="311150"/>
                  <a:pt x="427831" y="311150"/>
                </a:cubicBezTo>
                <a:cubicBezTo>
                  <a:pt x="341910" y="311150"/>
                  <a:pt x="272256" y="241496"/>
                  <a:pt x="272256" y="155575"/>
                </a:cubicBezTo>
                <a:cubicBezTo>
                  <a:pt x="272256" y="69653"/>
                  <a:pt x="341910" y="0"/>
                  <a:pt x="427831" y="0"/>
                </a:cubicBezTo>
                <a:close/>
              </a:path>
            </a:pathLst>
          </a:custGeom>
          <a:solidFill>
            <a:srgbClr val="AA0065"/>
          </a:solidFill>
          <a:ln w="15081" cap="flat">
            <a:noFill/>
            <a:prstDash val="solid"/>
            <a:miter/>
          </a:ln>
        </p:spPr>
        <p:txBody>
          <a:bodyPr wrap="square" rtlCol="0" anchor="ctr">
            <a:noAutofit/>
          </a:bodyPr>
          <a:lstStyle/>
          <a:p>
            <a:endParaRPr lang="en-US"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pic>
        <p:nvPicPr>
          <p:cNvPr id="19" name="Resim 18">
            <a:extLst>
              <a:ext uri="{FF2B5EF4-FFF2-40B4-BE49-F238E27FC236}">
                <a16:creationId xmlns:a16="http://schemas.microsoft.com/office/drawing/2014/main" id="{13FCD0CF-1B48-7BF6-89DE-C9E0C0E26D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745180" y="2627613"/>
            <a:ext cx="1888698" cy="1513956"/>
          </a:xfrm>
          <a:prstGeom prst="rect">
            <a:avLst/>
          </a:prstGeom>
        </p:spPr>
      </p:pic>
      <p:pic>
        <p:nvPicPr>
          <p:cNvPr id="20" name="Resim 19">
            <a:extLst>
              <a:ext uri="{FF2B5EF4-FFF2-40B4-BE49-F238E27FC236}">
                <a16:creationId xmlns:a16="http://schemas.microsoft.com/office/drawing/2014/main" id="{79EABEF1-6476-D61B-0C76-5C2D72B2B5A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061474" y="2620554"/>
            <a:ext cx="1888698" cy="1511684"/>
          </a:xfrm>
          <a:prstGeom prst="rect">
            <a:avLst/>
          </a:prstGeom>
          <a:noFill/>
          <a:ln>
            <a:noFill/>
          </a:ln>
        </p:spPr>
      </p:pic>
      <p:sp>
        <p:nvSpPr>
          <p:cNvPr id="21" name="TextBox 21">
            <a:extLst>
              <a:ext uri="{FF2B5EF4-FFF2-40B4-BE49-F238E27FC236}">
                <a16:creationId xmlns:a16="http://schemas.microsoft.com/office/drawing/2014/main" id="{48A0C44B-F32C-9F63-530A-279E70F0132C}"/>
              </a:ext>
            </a:extLst>
          </p:cNvPr>
          <p:cNvSpPr txBox="1"/>
          <p:nvPr/>
        </p:nvSpPr>
        <p:spPr>
          <a:xfrm>
            <a:off x="5260132" y="4155356"/>
            <a:ext cx="6758420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VC collapsibility index</a:t>
            </a:r>
            <a:r>
              <a:rPr lang="tr-TR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noProof="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increased post-dialysis</a:t>
            </a:r>
            <a:r>
              <a:rPr lang="en-US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(26.3±10.0% vs. 44.4 ± 9.4%; p&lt;0.001)</a:t>
            </a:r>
            <a:r>
              <a:rPr lang="tr-TR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tr-TR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</a:t>
            </a:r>
            <a:r>
              <a:rPr lang="en-US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he total number of B-lines</a:t>
            </a:r>
            <a:r>
              <a:rPr lang="tr-TR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noProof="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decreased post-dialysis</a:t>
            </a:r>
            <a:r>
              <a:rPr lang="tr-TR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(median 22 vs. 11.5; p&lt;0.001)</a:t>
            </a:r>
            <a:endParaRPr lang="tr-TR" sz="1600" dirty="0">
              <a:solidFill>
                <a:srgbClr val="00437A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noProof="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The</a:t>
            </a:r>
            <a:r>
              <a:rPr lang="tr-TR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UC for the total number of B-lines in predicting severe overhydration was 0.685 when assessed by BIS and 0.740</a:t>
            </a:r>
            <a:r>
              <a:rPr lang="tr-TR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US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when assessed by weight.</a:t>
            </a:r>
            <a:endParaRPr lang="tr-TR" sz="1600" dirty="0">
              <a:solidFill>
                <a:srgbClr val="00437A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29" name="TextBox 21">
            <a:extLst>
              <a:ext uri="{FF2B5EF4-FFF2-40B4-BE49-F238E27FC236}">
                <a16:creationId xmlns:a16="http://schemas.microsoft.com/office/drawing/2014/main" id="{FF8994AC-F9F1-7B90-FE07-D6C421D882DA}"/>
              </a:ext>
            </a:extLst>
          </p:cNvPr>
          <p:cNvSpPr txBox="1"/>
          <p:nvPr/>
        </p:nvSpPr>
        <p:spPr>
          <a:xfrm>
            <a:off x="5260132" y="1757848"/>
            <a:ext cx="666394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sz="1600" dirty="0">
                <a:solidFill>
                  <a:srgbClr val="00437A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A positive correlation was observed between the total number of B-lines and fluid overload measured by BIS both pre-dialysis (r=0.504, p=0.006) and post-dialysis (r=0.528, p=0.004).</a:t>
            </a:r>
            <a:endParaRPr lang="tr-TR" sz="1600" dirty="0">
              <a:solidFill>
                <a:srgbClr val="00437A"/>
              </a:solidFill>
              <a:latin typeface="Calibri" panose="020F0502020204030204" pitchFamily="34" charset="0"/>
              <a:ea typeface="Calibri" panose="020F0502020204030204" pitchFamily="34" charset="0"/>
              <a:cs typeface="Calibri" panose="020F0502020204030204" pitchFamily="34" charset="0"/>
            </a:endParaRPr>
          </a:p>
        </p:txBody>
      </p:sp>
      <p:sp>
        <p:nvSpPr>
          <p:cNvPr id="8" name="Rectangle 58">
            <a:extLst>
              <a:ext uri="{FF2B5EF4-FFF2-40B4-BE49-F238E27FC236}">
                <a16:creationId xmlns:a16="http://schemas.microsoft.com/office/drawing/2014/main" id="{92085C6E-AFD7-FE67-047A-06EA0C9F6C64}"/>
              </a:ext>
            </a:extLst>
          </p:cNvPr>
          <p:cNvSpPr/>
          <p:nvPr/>
        </p:nvSpPr>
        <p:spPr>
          <a:xfrm>
            <a:off x="1953920" y="4498718"/>
            <a:ext cx="3197200" cy="1126399"/>
          </a:xfrm>
          <a:prstGeom prst="rect">
            <a:avLst/>
          </a:prstGeom>
          <a:noFill/>
          <a:ln w="41275">
            <a:solidFill>
              <a:srgbClr val="AA0065"/>
            </a:solidFill>
            <a:round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just"/>
            <a:r>
              <a:rPr lang="en-US" sz="1600" dirty="0">
                <a:solidFill>
                  <a:srgbClr val="AA0065"/>
                </a:solidFill>
                <a:latin typeface="Calibri" panose="020F0502020204030204" pitchFamily="34" charset="0"/>
                <a:ea typeface="Calibri" panose="020F0502020204030204" pitchFamily="34" charset="0"/>
                <a:cs typeface="Calibri" panose="020F0502020204030204" pitchFamily="34" charset="0"/>
              </a:rPr>
              <a:t>Measurements were done before and after a 2-hour dwell exchange using either 2.27% glucose or 2.5% dextrose-based dialysate</a:t>
            </a:r>
          </a:p>
        </p:txBody>
      </p: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eması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</TotalTime>
  <Words>239</Words>
  <Application>Microsoft Office PowerPoint</Application>
  <PresentationFormat>Geniş ekran</PresentationFormat>
  <Paragraphs>14</Paragraphs>
  <Slides>1</Slides>
  <Notes>0</Notes>
  <HiddenSlides>0</HiddenSlides>
  <MMClips>0</MMClips>
  <ScaleCrop>false</ScaleCrop>
  <HeadingPairs>
    <vt:vector size="6" baseType="variant">
      <vt:variant>
        <vt:lpstr>Kullanılan Yazı Tipleri</vt:lpstr>
      </vt:variant>
      <vt:variant>
        <vt:i4>5</vt:i4>
      </vt:variant>
      <vt:variant>
        <vt:lpstr>Tema</vt:lpstr>
      </vt:variant>
      <vt:variant>
        <vt:i4>1</vt:i4>
      </vt:variant>
      <vt:variant>
        <vt:lpstr>Slayt Başlıkları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rial</vt:lpstr>
      <vt:lpstr>Calibri</vt:lpstr>
      <vt:lpstr>Calibri Light</vt:lpstr>
      <vt:lpstr>Office Teması</vt:lpstr>
      <vt:lpstr>PowerPoint Sunusu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Bahriye ATMIŞ</dc:creator>
  <cp:lastModifiedBy>Bahriye ATMIŞ</cp:lastModifiedBy>
  <cp:revision>11</cp:revision>
  <dcterms:created xsi:type="dcterms:W3CDTF">2025-02-06T18:29:06Z</dcterms:created>
  <dcterms:modified xsi:type="dcterms:W3CDTF">2025-04-20T11:13:23Z</dcterms:modified>
</cp:coreProperties>
</file>